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63" d="100"/>
          <a:sy n="163" d="100"/>
        </p:scale>
        <p:origin x="144" y="4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296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629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549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90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662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465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377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649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996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539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283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0E9B7-7573-40E9-B073-32CA0EC4C0F0}" type="datetimeFigureOut">
              <a:rPr lang="en-US" smtClean="0"/>
              <a:t>5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A4239-11AB-4DA7-94A7-86C3CAA12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768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88965FE2-CF83-F448-1116-1CFE5814A2E3}"/>
              </a:ext>
            </a:extLst>
          </p:cNvPr>
          <p:cNvGrpSpPr/>
          <p:nvPr/>
        </p:nvGrpSpPr>
        <p:grpSpPr>
          <a:xfrm>
            <a:off x="3549974" y="1637046"/>
            <a:ext cx="5092052" cy="3583909"/>
            <a:chOff x="3118228" y="1282917"/>
            <a:chExt cx="5092052" cy="3583909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2614856F-902B-4A56-9CE6-BA65770E43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3168710" y="1991173"/>
              <a:ext cx="5041570" cy="2875653"/>
            </a:xfrm>
            <a:prstGeom prst="rect">
              <a:avLst/>
            </a:prstGeom>
          </p:spPr>
        </p:pic>
        <p:sp>
          <p:nvSpPr>
            <p:cNvPr id="8" name="직사각형 7">
              <a:extLst>
                <a:ext uri="{FF2B5EF4-FFF2-40B4-BE49-F238E27FC236}">
                  <a16:creationId xmlns:a16="http://schemas.microsoft.com/office/drawing/2014/main" id="{5E0358C0-DB59-425A-A940-C3F0FE997E89}"/>
                </a:ext>
              </a:extLst>
            </p:cNvPr>
            <p:cNvSpPr/>
            <p:nvPr/>
          </p:nvSpPr>
          <p:spPr>
            <a:xfrm>
              <a:off x="3892068" y="3725282"/>
              <a:ext cx="1210277" cy="54747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C0700EC-8830-480D-A0DA-DDF6995EE1E1}"/>
                </a:ext>
              </a:extLst>
            </p:cNvPr>
            <p:cNvSpPr txBox="1"/>
            <p:nvPr/>
          </p:nvSpPr>
          <p:spPr>
            <a:xfrm>
              <a:off x="5021778" y="1428148"/>
              <a:ext cx="14325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H3K27me3</a:t>
              </a:r>
            </a:p>
          </p:txBody>
        </p: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D76B5D62-6C22-C2E7-83DA-9EF5ABFC30EF}"/>
                </a:ext>
              </a:extLst>
            </p:cNvPr>
            <p:cNvGrpSpPr/>
            <p:nvPr/>
          </p:nvGrpSpPr>
          <p:grpSpPr>
            <a:xfrm>
              <a:off x="3118228" y="1282917"/>
              <a:ext cx="4952282" cy="914400"/>
              <a:chOff x="322267" y="-177143"/>
              <a:chExt cx="4952282" cy="914400"/>
            </a:xfrm>
          </p:grpSpPr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A2B9580F-7619-5E0E-CF50-F88757058428}"/>
                  </a:ext>
                </a:extLst>
              </p:cNvPr>
              <p:cNvSpPr txBox="1"/>
              <p:nvPr/>
            </p:nvSpPr>
            <p:spPr>
              <a:xfrm rot="18945586">
                <a:off x="952790" y="131049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TeSR1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2E549D6-0811-1924-8E86-B6C13B5E367D}"/>
                  </a:ext>
                </a:extLst>
              </p:cNvPr>
              <p:cNvSpPr txBox="1"/>
              <p:nvPr/>
            </p:nvSpPr>
            <p:spPr>
              <a:xfrm rot="18782040">
                <a:off x="1535512" y="141557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ME7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3F05FCD3-2A5A-503E-67FF-CFE50ED614E7}"/>
                  </a:ext>
                </a:extLst>
              </p:cNvPr>
              <p:cNvSpPr txBox="1"/>
              <p:nvPr/>
            </p:nvSpPr>
            <p:spPr>
              <a:xfrm>
                <a:off x="2347929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EB633F70-D3C1-BAA6-6AE3-EAF00183B5BC}"/>
                  </a:ext>
                </a:extLst>
              </p:cNvPr>
              <p:cNvSpPr txBox="1"/>
              <p:nvPr/>
            </p:nvSpPr>
            <p:spPr>
              <a:xfrm>
                <a:off x="2894296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D5900D62-9B6C-BB95-CB81-82E9DE1671E3}"/>
                  </a:ext>
                </a:extLst>
              </p:cNvPr>
              <p:cNvSpPr txBox="1"/>
              <p:nvPr/>
            </p:nvSpPr>
            <p:spPr>
              <a:xfrm>
                <a:off x="3466002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E80F7AAA-4500-DEDA-2824-31B5742E74B5}"/>
                  </a:ext>
                </a:extLst>
              </p:cNvPr>
              <p:cNvSpPr txBox="1"/>
              <p:nvPr/>
            </p:nvSpPr>
            <p:spPr>
              <a:xfrm>
                <a:off x="4012369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EEC06A7B-F225-7441-C195-2B13F8B05296}"/>
                  </a:ext>
                </a:extLst>
              </p:cNvPr>
              <p:cNvSpPr txBox="1"/>
              <p:nvPr/>
            </p:nvSpPr>
            <p:spPr>
              <a:xfrm>
                <a:off x="322267" y="27759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dder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4612CA08-B7ED-1D6B-965D-5A655FB364CB}"/>
                  </a:ext>
                </a:extLst>
              </p:cNvPr>
              <p:cNvSpPr txBox="1"/>
              <p:nvPr/>
            </p:nvSpPr>
            <p:spPr>
              <a:xfrm>
                <a:off x="4360149" y="27759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dder</a:t>
                </a:r>
              </a:p>
            </p:txBody>
          </p:sp>
        </p:grp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027C0FB-2C96-79C2-D180-A7B135B30FC1}"/>
              </a:ext>
            </a:extLst>
          </p:cNvPr>
          <p:cNvGrpSpPr/>
          <p:nvPr/>
        </p:nvGrpSpPr>
        <p:grpSpPr>
          <a:xfrm>
            <a:off x="3033085" y="2493641"/>
            <a:ext cx="519694" cy="2406837"/>
            <a:chOff x="2646217" y="2147807"/>
            <a:chExt cx="519694" cy="2406837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8740646-DE1C-4CF8-8B05-9E0DAE3330A8}"/>
                </a:ext>
              </a:extLst>
            </p:cNvPr>
            <p:cNvSpPr txBox="1"/>
            <p:nvPr/>
          </p:nvSpPr>
          <p:spPr>
            <a:xfrm>
              <a:off x="2646217" y="2147807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8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3363A53-C6D3-4E90-466E-C5F18F7E4B2B}"/>
                </a:ext>
              </a:extLst>
            </p:cNvPr>
            <p:cNvSpPr txBox="1"/>
            <p:nvPr/>
          </p:nvSpPr>
          <p:spPr>
            <a:xfrm>
              <a:off x="2646217" y="2225447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3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0427D45-0EE0-50D0-98F6-62D0AF07192B}"/>
                </a:ext>
              </a:extLst>
            </p:cNvPr>
            <p:cNvSpPr txBox="1"/>
            <p:nvPr/>
          </p:nvSpPr>
          <p:spPr>
            <a:xfrm>
              <a:off x="2646217" y="2363251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0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D3617C5-EB08-37F7-DD03-7378FDDB2600}"/>
                </a:ext>
              </a:extLst>
            </p:cNvPr>
            <p:cNvSpPr txBox="1"/>
            <p:nvPr/>
          </p:nvSpPr>
          <p:spPr>
            <a:xfrm>
              <a:off x="2646217" y="2524011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B69509B-7699-75D2-1700-AD79476B74C5}"/>
                </a:ext>
              </a:extLst>
            </p:cNvPr>
            <p:cNvSpPr txBox="1"/>
            <p:nvPr/>
          </p:nvSpPr>
          <p:spPr>
            <a:xfrm>
              <a:off x="2646217" y="2706892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A9114F8-C455-66F6-9B9A-BAE9107FD4FF}"/>
                </a:ext>
              </a:extLst>
            </p:cNvPr>
            <p:cNvSpPr txBox="1"/>
            <p:nvPr/>
          </p:nvSpPr>
          <p:spPr>
            <a:xfrm>
              <a:off x="2646217" y="2922336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04D2E36-8CB4-044E-B443-A9C0EFD5B02C}"/>
                </a:ext>
              </a:extLst>
            </p:cNvPr>
            <p:cNvSpPr txBox="1"/>
            <p:nvPr/>
          </p:nvSpPr>
          <p:spPr>
            <a:xfrm>
              <a:off x="2646217" y="3150835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BACCC27-AFE5-146F-7B64-D7AF62EC8473}"/>
                </a:ext>
              </a:extLst>
            </p:cNvPr>
            <p:cNvSpPr txBox="1"/>
            <p:nvPr/>
          </p:nvSpPr>
          <p:spPr>
            <a:xfrm>
              <a:off x="2646217" y="3413076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95FDBDB-D77F-F937-5E48-03685203F3E9}"/>
                </a:ext>
              </a:extLst>
            </p:cNvPr>
            <p:cNvSpPr txBox="1"/>
            <p:nvPr/>
          </p:nvSpPr>
          <p:spPr>
            <a:xfrm>
              <a:off x="2646217" y="3840969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27407CE-57AA-5A1F-C78F-0AECC6282E1E}"/>
                </a:ext>
              </a:extLst>
            </p:cNvPr>
            <p:cNvSpPr txBox="1"/>
            <p:nvPr/>
          </p:nvSpPr>
          <p:spPr>
            <a:xfrm>
              <a:off x="2646217" y="4339200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97495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E64393DD-2416-1E3F-CE2C-55A93BA491FD}"/>
              </a:ext>
            </a:extLst>
          </p:cNvPr>
          <p:cNvGrpSpPr/>
          <p:nvPr/>
        </p:nvGrpSpPr>
        <p:grpSpPr>
          <a:xfrm>
            <a:off x="3576732" y="1637045"/>
            <a:ext cx="5038537" cy="3583911"/>
            <a:chOff x="3717814" y="1114737"/>
            <a:chExt cx="5038537" cy="3583911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471A4E35-3102-4099-AA4D-17E1ACC34C8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7814" y="1822995"/>
              <a:ext cx="5038537" cy="2875653"/>
            </a:xfrm>
            <a:prstGeom prst="rect">
              <a:avLst/>
            </a:prstGeom>
          </p:spPr>
        </p:pic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146E38E7-E33A-473D-8DFB-72D73D344C32}"/>
                </a:ext>
              </a:extLst>
            </p:cNvPr>
            <p:cNvSpPr/>
            <p:nvPr/>
          </p:nvSpPr>
          <p:spPr>
            <a:xfrm>
              <a:off x="4416430" y="2665469"/>
              <a:ext cx="1304622" cy="54747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4EA5544-1EFC-46FF-9F32-C01D47C1CD30}"/>
                </a:ext>
              </a:extLst>
            </p:cNvPr>
            <p:cNvSpPr txBox="1"/>
            <p:nvPr/>
          </p:nvSpPr>
          <p:spPr>
            <a:xfrm>
              <a:off x="5591948" y="1207210"/>
              <a:ext cx="14325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OCT4</a:t>
              </a:r>
            </a:p>
          </p:txBody>
        </p: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D05BB79D-1B15-31F1-BCE8-10EAA6E2DB72}"/>
                </a:ext>
              </a:extLst>
            </p:cNvPr>
            <p:cNvGrpSpPr/>
            <p:nvPr/>
          </p:nvGrpSpPr>
          <p:grpSpPr>
            <a:xfrm>
              <a:off x="3755784" y="1114737"/>
              <a:ext cx="4952282" cy="914400"/>
              <a:chOff x="322267" y="-177143"/>
              <a:chExt cx="4952282" cy="914400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10453C8C-127A-F2A7-4FDB-24A153CC7E8F}"/>
                  </a:ext>
                </a:extLst>
              </p:cNvPr>
              <p:cNvSpPr txBox="1"/>
              <p:nvPr/>
            </p:nvSpPr>
            <p:spPr>
              <a:xfrm rot="18945586">
                <a:off x="952790" y="131049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TeSR1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FAD3389B-36D1-DA6C-D192-E2669AA1D9DD}"/>
                  </a:ext>
                </a:extLst>
              </p:cNvPr>
              <p:cNvSpPr txBox="1"/>
              <p:nvPr/>
            </p:nvSpPr>
            <p:spPr>
              <a:xfrm rot="18782040">
                <a:off x="1535512" y="141557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ME7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85ECA670-ACBC-A4FE-B6B1-E6BAE1FB8605}"/>
                  </a:ext>
                </a:extLst>
              </p:cNvPr>
              <p:cNvSpPr txBox="1"/>
              <p:nvPr/>
            </p:nvSpPr>
            <p:spPr>
              <a:xfrm>
                <a:off x="2347929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CFABD6A2-2B31-2B70-5A35-A87E7112B4BF}"/>
                  </a:ext>
                </a:extLst>
              </p:cNvPr>
              <p:cNvSpPr txBox="1"/>
              <p:nvPr/>
            </p:nvSpPr>
            <p:spPr>
              <a:xfrm>
                <a:off x="2894296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7B20AB6F-147F-B2E0-AF35-B47422E2C68B}"/>
                  </a:ext>
                </a:extLst>
              </p:cNvPr>
              <p:cNvSpPr txBox="1"/>
              <p:nvPr/>
            </p:nvSpPr>
            <p:spPr>
              <a:xfrm>
                <a:off x="3466002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E939F46E-AADF-2934-5824-D009B04985AF}"/>
                  </a:ext>
                </a:extLst>
              </p:cNvPr>
              <p:cNvSpPr txBox="1"/>
              <p:nvPr/>
            </p:nvSpPr>
            <p:spPr>
              <a:xfrm>
                <a:off x="4012369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11213CAA-B638-DA67-4846-83BBD6781774}"/>
                  </a:ext>
                </a:extLst>
              </p:cNvPr>
              <p:cNvSpPr txBox="1"/>
              <p:nvPr/>
            </p:nvSpPr>
            <p:spPr>
              <a:xfrm>
                <a:off x="322267" y="27759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dder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DA04BB08-22DA-1DE5-1097-313B257513C5}"/>
                  </a:ext>
                </a:extLst>
              </p:cNvPr>
              <p:cNvSpPr txBox="1"/>
              <p:nvPr/>
            </p:nvSpPr>
            <p:spPr>
              <a:xfrm>
                <a:off x="4360149" y="27759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dder</a:t>
                </a: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E1A96F22-8265-A313-6D42-DAB3363106CE}"/>
              </a:ext>
            </a:extLst>
          </p:cNvPr>
          <p:cNvGrpSpPr/>
          <p:nvPr/>
        </p:nvGrpSpPr>
        <p:grpSpPr>
          <a:xfrm>
            <a:off x="3038947" y="2704653"/>
            <a:ext cx="519694" cy="2406837"/>
            <a:chOff x="2646217" y="2147807"/>
            <a:chExt cx="519694" cy="2406837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C2F059E-B5D2-7604-7BB3-9C9032413572}"/>
                </a:ext>
              </a:extLst>
            </p:cNvPr>
            <p:cNvSpPr txBox="1"/>
            <p:nvPr/>
          </p:nvSpPr>
          <p:spPr>
            <a:xfrm>
              <a:off x="2646217" y="2147807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8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2FF1308-B0B9-1F1C-CA5E-57AD15F7E476}"/>
                </a:ext>
              </a:extLst>
            </p:cNvPr>
            <p:cNvSpPr txBox="1"/>
            <p:nvPr/>
          </p:nvSpPr>
          <p:spPr>
            <a:xfrm>
              <a:off x="2646217" y="2225447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3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AF537FC-2217-90A0-3772-04DE74DC4862}"/>
                </a:ext>
              </a:extLst>
            </p:cNvPr>
            <p:cNvSpPr txBox="1"/>
            <p:nvPr/>
          </p:nvSpPr>
          <p:spPr>
            <a:xfrm>
              <a:off x="2646217" y="2363251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0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AF104DA-0B7C-0BBD-0C88-D983BA33D93C}"/>
                </a:ext>
              </a:extLst>
            </p:cNvPr>
            <p:cNvSpPr txBox="1"/>
            <p:nvPr/>
          </p:nvSpPr>
          <p:spPr>
            <a:xfrm>
              <a:off x="2646217" y="2524011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6799156-1E4C-5A44-761F-5540D4AC50D3}"/>
                </a:ext>
              </a:extLst>
            </p:cNvPr>
            <p:cNvSpPr txBox="1"/>
            <p:nvPr/>
          </p:nvSpPr>
          <p:spPr>
            <a:xfrm>
              <a:off x="2646217" y="2706892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C0CE17D-6843-0BE4-B884-E7048E04D210}"/>
                </a:ext>
              </a:extLst>
            </p:cNvPr>
            <p:cNvSpPr txBox="1"/>
            <p:nvPr/>
          </p:nvSpPr>
          <p:spPr>
            <a:xfrm>
              <a:off x="2646217" y="2922336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4C8114C-50FF-41E0-43CB-25F7A95D9D7E}"/>
                </a:ext>
              </a:extLst>
            </p:cNvPr>
            <p:cNvSpPr txBox="1"/>
            <p:nvPr/>
          </p:nvSpPr>
          <p:spPr>
            <a:xfrm>
              <a:off x="2646217" y="3150835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3D8E044-CF88-3F81-C126-1649618220D3}"/>
                </a:ext>
              </a:extLst>
            </p:cNvPr>
            <p:cNvSpPr txBox="1"/>
            <p:nvPr/>
          </p:nvSpPr>
          <p:spPr>
            <a:xfrm>
              <a:off x="2646217" y="3413076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0D48E24-ACB0-3617-8254-0B721BB68DB7}"/>
                </a:ext>
              </a:extLst>
            </p:cNvPr>
            <p:cNvSpPr txBox="1"/>
            <p:nvPr/>
          </p:nvSpPr>
          <p:spPr>
            <a:xfrm>
              <a:off x="2646217" y="3840969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A6BE18A-4CD8-8E53-EFAB-DC9F617ECE5B}"/>
                </a:ext>
              </a:extLst>
            </p:cNvPr>
            <p:cNvSpPr txBox="1"/>
            <p:nvPr/>
          </p:nvSpPr>
          <p:spPr>
            <a:xfrm>
              <a:off x="2646217" y="4339200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938222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4507708D-D698-FA91-3801-83EA9EB2A7DD}"/>
              </a:ext>
            </a:extLst>
          </p:cNvPr>
          <p:cNvGrpSpPr/>
          <p:nvPr/>
        </p:nvGrpSpPr>
        <p:grpSpPr>
          <a:xfrm>
            <a:off x="3542168" y="1667410"/>
            <a:ext cx="5107664" cy="3523180"/>
            <a:chOff x="3452335" y="1507454"/>
            <a:chExt cx="5107664" cy="3523180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2CD87BCD-182D-47AF-9301-9961708AB76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2817" y="2239187"/>
              <a:ext cx="5057182" cy="2791447"/>
            </a:xfrm>
            <a:prstGeom prst="rect">
              <a:avLst/>
            </a:prstGeom>
          </p:spPr>
        </p:pic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C768F8D0-7AF6-41F5-A930-CE43646BE788}"/>
                </a:ext>
              </a:extLst>
            </p:cNvPr>
            <p:cNvSpPr/>
            <p:nvPr/>
          </p:nvSpPr>
          <p:spPr>
            <a:xfrm>
              <a:off x="4173421" y="3175697"/>
              <a:ext cx="1182463" cy="531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67E5C36-BFC7-4E43-96BF-CD56E759DF7A}"/>
                </a:ext>
              </a:extLst>
            </p:cNvPr>
            <p:cNvSpPr txBox="1"/>
            <p:nvPr/>
          </p:nvSpPr>
          <p:spPr>
            <a:xfrm>
              <a:off x="5315128" y="1592856"/>
              <a:ext cx="14325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F80376DF-E427-E803-5110-A62805E7ACA6}"/>
                </a:ext>
              </a:extLst>
            </p:cNvPr>
            <p:cNvGrpSpPr/>
            <p:nvPr/>
          </p:nvGrpSpPr>
          <p:grpSpPr>
            <a:xfrm>
              <a:off x="3452335" y="1507454"/>
              <a:ext cx="4952282" cy="914400"/>
              <a:chOff x="322267" y="-177143"/>
              <a:chExt cx="4952282" cy="914400"/>
            </a:xfrm>
          </p:grpSpPr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A450B7AD-6AC2-D795-6FB4-5D44EF0CB62F}"/>
                  </a:ext>
                </a:extLst>
              </p:cNvPr>
              <p:cNvSpPr txBox="1"/>
              <p:nvPr/>
            </p:nvSpPr>
            <p:spPr>
              <a:xfrm rot="18945586">
                <a:off x="952790" y="131049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TeSR1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ACCEE84-EE04-3DB0-A19B-78E7F35B2503}"/>
                  </a:ext>
                </a:extLst>
              </p:cNvPr>
              <p:cNvSpPr txBox="1"/>
              <p:nvPr/>
            </p:nvSpPr>
            <p:spPr>
              <a:xfrm rot="18782040">
                <a:off x="1535512" y="141557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ME7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671A96A6-DA4C-F41D-D564-607D69A660CF}"/>
                  </a:ext>
                </a:extLst>
              </p:cNvPr>
              <p:cNvSpPr txBox="1"/>
              <p:nvPr/>
            </p:nvSpPr>
            <p:spPr>
              <a:xfrm>
                <a:off x="2347929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CFB7209D-AF61-81C5-142E-3043F35C8AB6}"/>
                  </a:ext>
                </a:extLst>
              </p:cNvPr>
              <p:cNvSpPr txBox="1"/>
              <p:nvPr/>
            </p:nvSpPr>
            <p:spPr>
              <a:xfrm>
                <a:off x="2894296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E6EAF650-684A-E36B-4516-D0041DEFAEBD}"/>
                  </a:ext>
                </a:extLst>
              </p:cNvPr>
              <p:cNvSpPr txBox="1"/>
              <p:nvPr/>
            </p:nvSpPr>
            <p:spPr>
              <a:xfrm>
                <a:off x="3466002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3203BEE7-2765-116B-0A03-0717F7756D71}"/>
                  </a:ext>
                </a:extLst>
              </p:cNvPr>
              <p:cNvSpPr txBox="1"/>
              <p:nvPr/>
            </p:nvSpPr>
            <p:spPr>
              <a:xfrm>
                <a:off x="4012369" y="27759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E06B978-46BC-9402-B25E-FECC5241EB37}"/>
                  </a:ext>
                </a:extLst>
              </p:cNvPr>
              <p:cNvSpPr txBox="1"/>
              <p:nvPr/>
            </p:nvSpPr>
            <p:spPr>
              <a:xfrm>
                <a:off x="322267" y="27759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dder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8EDD2402-1E5B-7D7E-D1E7-C75090B1459A}"/>
                  </a:ext>
                </a:extLst>
              </p:cNvPr>
              <p:cNvSpPr txBox="1"/>
              <p:nvPr/>
            </p:nvSpPr>
            <p:spPr>
              <a:xfrm>
                <a:off x="4360149" y="27759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dder</a:t>
                </a: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CC1C26E7-BD07-F299-3526-0E5DE425BC0F}"/>
              </a:ext>
            </a:extLst>
          </p:cNvPr>
          <p:cNvGrpSpPr/>
          <p:nvPr/>
        </p:nvGrpSpPr>
        <p:grpSpPr>
          <a:xfrm>
            <a:off x="3038947" y="2810165"/>
            <a:ext cx="519694" cy="1908606"/>
            <a:chOff x="2646217" y="2147807"/>
            <a:chExt cx="519694" cy="1908606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823FCCD-2511-3A1C-8882-A4B5CCC8C847}"/>
                </a:ext>
              </a:extLst>
            </p:cNvPr>
            <p:cNvSpPr txBox="1"/>
            <p:nvPr/>
          </p:nvSpPr>
          <p:spPr>
            <a:xfrm>
              <a:off x="2646217" y="2147807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8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3C02697-FE6A-49F1-7234-B164DDCD7D01}"/>
                </a:ext>
              </a:extLst>
            </p:cNvPr>
            <p:cNvSpPr txBox="1"/>
            <p:nvPr/>
          </p:nvSpPr>
          <p:spPr>
            <a:xfrm>
              <a:off x="2646217" y="2225447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3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F1B36A1-BCA3-F504-D8B4-D0A52569F9AA}"/>
                </a:ext>
              </a:extLst>
            </p:cNvPr>
            <p:cNvSpPr txBox="1"/>
            <p:nvPr/>
          </p:nvSpPr>
          <p:spPr>
            <a:xfrm>
              <a:off x="2646217" y="2363251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0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1EE60B6-EB17-CD2C-318F-9DA0059E9BC2}"/>
                </a:ext>
              </a:extLst>
            </p:cNvPr>
            <p:cNvSpPr txBox="1"/>
            <p:nvPr/>
          </p:nvSpPr>
          <p:spPr>
            <a:xfrm>
              <a:off x="2646217" y="2524011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2AF8F5F-7799-A023-B497-DDD75ADE3097}"/>
                </a:ext>
              </a:extLst>
            </p:cNvPr>
            <p:cNvSpPr txBox="1"/>
            <p:nvPr/>
          </p:nvSpPr>
          <p:spPr>
            <a:xfrm>
              <a:off x="2646217" y="2706892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959EE82-3D24-9334-2BF7-FCE5B70B15BF}"/>
                </a:ext>
              </a:extLst>
            </p:cNvPr>
            <p:cNvSpPr txBox="1"/>
            <p:nvPr/>
          </p:nvSpPr>
          <p:spPr>
            <a:xfrm>
              <a:off x="2646217" y="2922336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0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BFC0C70-8B4F-E2A4-BC68-ED76FB9ABF2B}"/>
                </a:ext>
              </a:extLst>
            </p:cNvPr>
            <p:cNvSpPr txBox="1"/>
            <p:nvPr/>
          </p:nvSpPr>
          <p:spPr>
            <a:xfrm>
              <a:off x="2646217" y="3150835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A176DB8-C70C-4C8E-230A-DE7D9A47CF8F}"/>
                </a:ext>
              </a:extLst>
            </p:cNvPr>
            <p:cNvSpPr txBox="1"/>
            <p:nvPr/>
          </p:nvSpPr>
          <p:spPr>
            <a:xfrm>
              <a:off x="2646217" y="3413076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A20A78E-90A3-C431-601C-FACBCD1AF931}"/>
                </a:ext>
              </a:extLst>
            </p:cNvPr>
            <p:cNvSpPr txBox="1"/>
            <p:nvPr/>
          </p:nvSpPr>
          <p:spPr>
            <a:xfrm>
              <a:off x="2646217" y="3840969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5 </a:t>
              </a:r>
              <a:r>
                <a:rPr lang="en-US" sz="800" dirty="0" err="1"/>
                <a:t>kDa</a:t>
              </a:r>
              <a:endParaRPr 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4226838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86</Words>
  <Application>Microsoft Office PowerPoint</Application>
  <PresentationFormat>Widescreen</PresentationFormat>
  <Paragraphs>5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won Jang</dc:creator>
  <cp:lastModifiedBy>Kevin Yi</cp:lastModifiedBy>
  <cp:revision>10</cp:revision>
  <dcterms:created xsi:type="dcterms:W3CDTF">2016-11-16T19:04:30Z</dcterms:created>
  <dcterms:modified xsi:type="dcterms:W3CDTF">2025-05-16T14:50:49Z</dcterms:modified>
</cp:coreProperties>
</file>